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9"/>
    <p:restoredTop sz="95313"/>
  </p:normalViewPr>
  <p:slideViewPr>
    <p:cSldViewPr snapToGrid="0" snapToObjects="1">
      <p:cViewPr varScale="1">
        <p:scale>
          <a:sx n="93" d="100"/>
          <a:sy n="93" d="100"/>
        </p:scale>
        <p:origin x="200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162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4209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797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754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2032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547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48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096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230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480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3764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B2B38-1B9B-3E41-9EBB-DFA06971F151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00FFF-4C98-F644-9A33-36EC174BD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742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777532D3-1BC2-AD4E-BA7C-8FE8D0F3E39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371311" y="1086095"/>
          <a:ext cx="6193272" cy="437259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81920">
                  <a:extLst>
                    <a:ext uri="{9D8B030D-6E8A-4147-A177-3AD203B41FA5}">
                      <a16:colId xmlns:a16="http://schemas.microsoft.com/office/drawing/2014/main" val="66479382"/>
                    </a:ext>
                  </a:extLst>
                </a:gridCol>
                <a:gridCol w="1516660">
                  <a:extLst>
                    <a:ext uri="{9D8B030D-6E8A-4147-A177-3AD203B41FA5}">
                      <a16:colId xmlns:a16="http://schemas.microsoft.com/office/drawing/2014/main" val="3870299589"/>
                    </a:ext>
                  </a:extLst>
                </a:gridCol>
                <a:gridCol w="1294692">
                  <a:extLst>
                    <a:ext uri="{9D8B030D-6E8A-4147-A177-3AD203B41FA5}">
                      <a16:colId xmlns:a16="http://schemas.microsoft.com/office/drawing/2014/main" val="1341440043"/>
                    </a:ext>
                  </a:extLst>
                </a:gridCol>
              </a:tblGrid>
              <a:tr h="295658">
                <a:tc rowSpan="2"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1628386"/>
                  </a:ext>
                </a:extLst>
              </a:tr>
              <a:tr h="2956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6796233"/>
                  </a:ext>
                </a:extLst>
              </a:tr>
              <a:tr h="299764">
                <a:tc>
                  <a:txBody>
                    <a:bodyPr/>
                    <a:lstStyle/>
                    <a:p>
                      <a:pPr indent="153035" algn="just">
                        <a:spcAft>
                          <a:spcPts val="0"/>
                        </a:spcAft>
                      </a:pP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 parameter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26889102"/>
                  </a:ext>
                </a:extLst>
              </a:tr>
              <a:tr h="29976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7535000"/>
                  </a:ext>
                </a:extLst>
              </a:tr>
              <a:tr h="513296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without glucocorticoid do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9877239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SLEDAI scor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3775025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3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9824221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4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0271159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H50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1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02149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iter of anti-dsDNA antibod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7987412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agent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0609906"/>
                  </a:ext>
                </a:extLst>
              </a:tr>
              <a:tr h="30797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Glucocorticoid u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4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6580011"/>
                  </a:ext>
                </a:extLst>
              </a:tr>
              <a:tr h="512611">
                <a:tc>
                  <a:txBody>
                    <a:bodyPr/>
                    <a:lstStyle/>
                    <a:p>
                      <a:pPr indent="304800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prednisolone dose during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pregnanc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695250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FD799B8-E571-774D-A792-D81FD0B9C157}"/>
              </a:ext>
            </a:extLst>
          </p:cNvPr>
          <p:cNvSpPr txBox="1"/>
          <p:nvPr/>
        </p:nvSpPr>
        <p:spPr>
          <a:xfrm>
            <a:off x="806162" y="447239"/>
            <a:ext cx="554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. Relevance to low birth weight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10E6EB6-8BD4-6941-B0CD-709A0F2A9163}"/>
              </a:ext>
            </a:extLst>
          </p:cNvPr>
          <p:cNvSpPr txBox="1"/>
          <p:nvPr/>
        </p:nvSpPr>
        <p:spPr>
          <a:xfrm>
            <a:off x="1039091" y="5569527"/>
            <a:ext cx="70796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isher’s exact test, 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Wilcoxon rank sum test, *; P&lt;0.05. SLEDAI; systemic lupus erythematosus disease activity index, LLDAS; lupus low disease activity state, anti-dsDNA antibody; anti-double stranded DNA antibody)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4337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5</Words>
  <Application>Microsoft Macintosh PowerPoint</Application>
  <PresentationFormat>画面に合わせる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</cp:revision>
  <dcterms:created xsi:type="dcterms:W3CDTF">2020-08-01T02:33:27Z</dcterms:created>
  <dcterms:modified xsi:type="dcterms:W3CDTF">2020-08-01T02:34:21Z</dcterms:modified>
</cp:coreProperties>
</file>